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9C25D0-0F85-485B-8B98-67D5484318E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88EE16-DEC5-488D-8714-95137BD60B2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A15902-0AC5-4582-9081-9C0002AF92B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58EA82-DC81-4B77-85B3-3AA357B1C41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C3C0AB-2129-47F1-8E6E-0930DF554C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4BC243-1B8A-41DB-9C17-EB79628BF1D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F3E57A-948A-443B-BA58-0632FF4EC4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426CD1-A535-4FFE-AB84-F04D2957F0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A6D1BF-E4A3-49A6-BBD9-A894C2DDF6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19AB07-8732-4BBB-9E49-3EA7FE472E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2A8E11-C2C5-4B88-B84E-3ED06619CC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7966BE-E15A-4592-8600-CF4ABD8111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C810B58-A0AE-486F-8231-6CFB8C936CEE}" type="datetime">
              <a:rPr b="0" lang="zh-CN" sz="1200" spc="-1" strike="noStrike">
                <a:solidFill>
                  <a:srgbClr val="898989"/>
                </a:solidFill>
                <a:latin typeface="Calibri"/>
              </a:rPr>
              <a:t>26/8/29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0918889-F6F6-404D-9658-65DB7548F291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直线连接符 1"/>
          <p:cNvSpPr/>
          <p:nvPr/>
        </p:nvSpPr>
        <p:spPr>
          <a:xfrm>
            <a:off x="1495440" y="2395440"/>
            <a:ext cx="5364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直线连接符 23"/>
          <p:cNvSpPr/>
          <p:nvPr/>
        </p:nvSpPr>
        <p:spPr>
          <a:xfrm>
            <a:off x="1479600" y="4402080"/>
            <a:ext cx="5364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直线连接符 24"/>
          <p:cNvSpPr/>
          <p:nvPr/>
        </p:nvSpPr>
        <p:spPr>
          <a:xfrm>
            <a:off x="1495440" y="1998720"/>
            <a:ext cx="5364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文本框 65"/>
          <p:cNvSpPr/>
          <p:nvPr/>
        </p:nvSpPr>
        <p:spPr>
          <a:xfrm>
            <a:off x="-182520" y="1577880"/>
            <a:ext cx="8888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SUPPLEMENTARY TABLE </a:t>
            </a:r>
            <a:r>
              <a:rPr b="1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9 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Thermal Cycling Conditions (Mutant Plasmid Construction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文本框 57"/>
          <p:cNvSpPr/>
          <p:nvPr/>
        </p:nvSpPr>
        <p:spPr>
          <a:xfrm>
            <a:off x="1600200" y="4068720"/>
            <a:ext cx="7207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Hold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文本框 60"/>
          <p:cNvSpPr/>
          <p:nvPr/>
        </p:nvSpPr>
        <p:spPr>
          <a:xfrm>
            <a:off x="3776760" y="2432160"/>
            <a:ext cx="71892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94°C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文本框 61"/>
          <p:cNvSpPr/>
          <p:nvPr/>
        </p:nvSpPr>
        <p:spPr>
          <a:xfrm>
            <a:off x="1600200" y="2430360"/>
            <a:ext cx="17542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Initial denaturatio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文本框 62"/>
          <p:cNvSpPr/>
          <p:nvPr/>
        </p:nvSpPr>
        <p:spPr>
          <a:xfrm>
            <a:off x="4722840" y="2443320"/>
            <a:ext cx="1204920" cy="30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04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2 mi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文本框 4"/>
          <p:cNvSpPr/>
          <p:nvPr/>
        </p:nvSpPr>
        <p:spPr>
          <a:xfrm>
            <a:off x="3789360" y="2881440"/>
            <a:ext cx="71928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98°C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文本框 8"/>
          <p:cNvSpPr/>
          <p:nvPr/>
        </p:nvSpPr>
        <p:spPr>
          <a:xfrm>
            <a:off x="3741840" y="3639960"/>
            <a:ext cx="72072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68°C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文本框 11"/>
          <p:cNvSpPr/>
          <p:nvPr/>
        </p:nvSpPr>
        <p:spPr>
          <a:xfrm>
            <a:off x="3807000" y="4068720"/>
            <a:ext cx="72072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4°C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文本框 15"/>
          <p:cNvSpPr/>
          <p:nvPr/>
        </p:nvSpPr>
        <p:spPr>
          <a:xfrm>
            <a:off x="4713120" y="3621240"/>
            <a:ext cx="1203480" cy="36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5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 mi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文本框 19"/>
          <p:cNvSpPr/>
          <p:nvPr/>
        </p:nvSpPr>
        <p:spPr>
          <a:xfrm>
            <a:off x="4695840" y="2870280"/>
            <a:ext cx="120348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10s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文本框 29"/>
          <p:cNvSpPr/>
          <p:nvPr/>
        </p:nvSpPr>
        <p:spPr>
          <a:xfrm>
            <a:off x="4713120" y="4099680"/>
            <a:ext cx="120348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∞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文本框 32"/>
          <p:cNvSpPr/>
          <p:nvPr/>
        </p:nvSpPr>
        <p:spPr>
          <a:xfrm>
            <a:off x="5300640" y="4094280"/>
            <a:ext cx="2440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1X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文本框 33"/>
          <p:cNvSpPr/>
          <p:nvPr/>
        </p:nvSpPr>
        <p:spPr>
          <a:xfrm>
            <a:off x="5365800" y="2419200"/>
            <a:ext cx="2327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1X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文本框 34"/>
          <p:cNvSpPr/>
          <p:nvPr/>
        </p:nvSpPr>
        <p:spPr>
          <a:xfrm>
            <a:off x="1865160" y="2058840"/>
            <a:ext cx="8240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Step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文本框 37"/>
          <p:cNvSpPr/>
          <p:nvPr/>
        </p:nvSpPr>
        <p:spPr>
          <a:xfrm>
            <a:off x="5035680" y="2085840"/>
            <a:ext cx="12016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Time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文本框 38"/>
          <p:cNvSpPr/>
          <p:nvPr/>
        </p:nvSpPr>
        <p:spPr>
          <a:xfrm>
            <a:off x="6197760" y="2066760"/>
            <a:ext cx="6458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Cycle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文本框 10"/>
          <p:cNvSpPr/>
          <p:nvPr/>
        </p:nvSpPr>
        <p:spPr>
          <a:xfrm>
            <a:off x="3483000" y="2054160"/>
            <a:ext cx="11365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Temperature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文本框 5"/>
          <p:cNvSpPr/>
          <p:nvPr/>
        </p:nvSpPr>
        <p:spPr>
          <a:xfrm>
            <a:off x="1600200" y="2859120"/>
            <a:ext cx="12175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Denaturatio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文本框 6"/>
          <p:cNvSpPr/>
          <p:nvPr/>
        </p:nvSpPr>
        <p:spPr>
          <a:xfrm>
            <a:off x="1600200" y="3638520"/>
            <a:ext cx="20336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Annealing 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a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nd 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e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xtensio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文本框 20"/>
          <p:cNvSpPr/>
          <p:nvPr/>
        </p:nvSpPr>
        <p:spPr>
          <a:xfrm>
            <a:off x="5346720" y="3313080"/>
            <a:ext cx="2327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2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5X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右大括号 40"/>
          <p:cNvSpPr/>
          <p:nvPr/>
        </p:nvSpPr>
        <p:spPr>
          <a:xfrm>
            <a:off x="5754600" y="2978280"/>
            <a:ext cx="324000" cy="1008000"/>
          </a:xfrm>
          <a:custGeom>
            <a:avLst/>
            <a:gdLst>
              <a:gd name="textAreaLeft" fmla="*/ 0 w 324000"/>
              <a:gd name="textAreaRight" fmla="*/ 117000 w 324000"/>
              <a:gd name="textAreaTop" fmla="*/ 8280 h 1008000"/>
              <a:gd name="textAreaBottom" fmla="*/ 999720 h 1008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289"/>
                  <a:pt x="10800" y="578"/>
                </a:cubicBezTo>
                <a:lnTo>
                  <a:pt x="10800" y="10222"/>
                </a:lnTo>
                <a:cubicBezTo>
                  <a:pt x="10800" y="10511"/>
                  <a:pt x="16200" y="10800"/>
                  <a:pt x="21600" y="10800"/>
                </a:cubicBezTo>
                <a:cubicBezTo>
                  <a:pt x="16200" y="10800"/>
                  <a:pt x="10800" y="11089"/>
                  <a:pt x="10800" y="11378"/>
                </a:cubicBezTo>
                <a:lnTo>
                  <a:pt x="10800" y="21022"/>
                </a:lnTo>
                <a:cubicBezTo>
                  <a:pt x="10800" y="21311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8-09T12:44:00Z</dcterms:created>
  <dc:creator>ghl</dc:creator>
  <dc:description/>
  <dc:language>en-US</dc:language>
  <cp:lastModifiedBy>墨铁</cp:lastModifiedBy>
  <dcterms:modified xsi:type="dcterms:W3CDTF">2026-05-25T09:46:54Z</dcterms:modified>
  <cp:revision>57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4EF8A1A72F364BE3A5218373BDAA2C6E_13</vt:lpwstr>
  </property>
  <property fmtid="{D5CDD505-2E9C-101B-9397-08002B2CF9AE}" pid="3" name="KSOProductBuildVer">
    <vt:lpwstr>2052-12.1.0.26375</vt:lpwstr>
  </property>
</Properties>
</file>